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9298E5-2D9F-46D5-8E66-296B97509DE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CCAB20-FEFD-4CF8-BB1A-2C86BDD976C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8B644D-F34A-431B-BB99-50542627EC7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ydrate Ridge 0_6c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5C43F1-D575-4830-8C16-17F7CB04B20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anta Monica_0_4c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E934B1-5933-4CA6-93AB-90305CA44C4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ydrate Ridge_0_6c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BC6007-7374-4CD3-AE0C-87FB8CEE724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7F6CCE-9DFE-491B-B5FF-014E8784A74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ADF50D-23AD-4AAE-A1A3-AFAF6E9B3A2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06F34C-19D0-4194-8E68-769316085F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612BB-A611-48A0-8148-D719CB2635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47045-FDA3-4EBD-9F3E-FCB8F21311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96CC95-F071-4662-AD81-8A8A3D85F9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82BB2-25A4-4A00-AA86-A1D4C3A8FF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C2B48-0E66-4FC8-BD60-40588C2255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831112-B505-4791-8292-78F7216413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20F7D-73F5-4B5C-9D91-5FB14CD075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68F46-73F9-41D7-9BC5-BD5D891EB9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DD55D-EF17-48D6-8031-5A4D12ADB9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B9760-0693-4395-AD40-6F85D8A753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86F41-E4E4-4564-B3D6-BC8C4E5C0E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13C160-EB41-48B7-9912-73198C98478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"/>
          <p:cNvPicPr/>
          <p:nvPr/>
        </p:nvPicPr>
        <p:blipFill>
          <a:blip r:embed="rId1"/>
          <a:srcRect l="2527" t="0" r="0" b="3881"/>
          <a:stretch/>
        </p:blipFill>
        <p:spPr>
          <a:xfrm>
            <a:off x="1598760" y="914400"/>
            <a:ext cx="6249960" cy="3516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9" name="TextBox 4"/>
          <p:cNvSpPr/>
          <p:nvPr/>
        </p:nvSpPr>
        <p:spPr>
          <a:xfrm rot="16200000">
            <a:off x="470520" y="233748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Intensit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5"/>
          <p:cNvSpPr/>
          <p:nvPr/>
        </p:nvSpPr>
        <p:spPr>
          <a:xfrm>
            <a:off x="4191120" y="446580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6"/>
          <p:cNvSpPr/>
          <p:nvPr/>
        </p:nvSpPr>
        <p:spPr>
          <a:xfrm>
            <a:off x="1598760" y="5257800"/>
            <a:ext cx="6249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OEU55094.1 hypothetical protein BA871_14950 [Desulfuromonadales bacterium C00003096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pectrum from Hydrate Ridge 0-6 cm sediment samp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7"/>
          <p:cNvSpPr/>
          <p:nvPr/>
        </p:nvSpPr>
        <p:spPr>
          <a:xfrm>
            <a:off x="990720" y="609480"/>
            <a:ext cx="7238880" cy="449604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8"/>
          <p:cNvSpPr/>
          <p:nvPr/>
        </p:nvSpPr>
        <p:spPr>
          <a:xfrm>
            <a:off x="3207600" y="227160"/>
            <a:ext cx="246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eptidylprolyl isomera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3" descr=""/>
          <p:cNvPicPr/>
          <p:nvPr/>
        </p:nvPicPr>
        <p:blipFill>
          <a:blip r:embed="rId1"/>
          <a:srcRect l="3423" t="0" r="0" b="4307"/>
          <a:stretch/>
        </p:blipFill>
        <p:spPr>
          <a:xfrm>
            <a:off x="1650960" y="1066680"/>
            <a:ext cx="5740560" cy="4214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5" name="TextBox 4"/>
          <p:cNvSpPr/>
          <p:nvPr/>
        </p:nvSpPr>
        <p:spPr>
          <a:xfrm rot="16200000">
            <a:off x="470520" y="248832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Intensit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5"/>
          <p:cNvSpPr/>
          <p:nvPr/>
        </p:nvSpPr>
        <p:spPr>
          <a:xfrm>
            <a:off x="3962520" y="530856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tangle 6"/>
          <p:cNvSpPr/>
          <p:nvPr/>
        </p:nvSpPr>
        <p:spPr>
          <a:xfrm>
            <a:off x="1066680" y="838080"/>
            <a:ext cx="6477120" cy="487692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7"/>
          <p:cNvSpPr/>
          <p:nvPr/>
        </p:nvSpPr>
        <p:spPr>
          <a:xfrm>
            <a:off x="1336680" y="5791320"/>
            <a:ext cx="6054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OEU44960.1 hypothetical protein BBJ60_04640 [Desulfobacterales bacterium S7086C20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pectrum from Santa Monica 0-4 cm sediment samp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8"/>
          <p:cNvSpPr/>
          <p:nvPr/>
        </p:nvSpPr>
        <p:spPr>
          <a:xfrm>
            <a:off x="3071160" y="398520"/>
            <a:ext cx="246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eptidylprolyl isomera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3" descr=""/>
          <p:cNvPicPr/>
          <p:nvPr/>
        </p:nvPicPr>
        <p:blipFill>
          <a:blip r:embed="rId1"/>
          <a:srcRect l="3014" t="0" r="0" b="4007"/>
          <a:stretch/>
        </p:blipFill>
        <p:spPr>
          <a:xfrm>
            <a:off x="1295280" y="816120"/>
            <a:ext cx="6356520" cy="3530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1" name="TextBox 4"/>
          <p:cNvSpPr/>
          <p:nvPr/>
        </p:nvSpPr>
        <p:spPr>
          <a:xfrm rot="16200000">
            <a:off x="264240" y="2184840"/>
            <a:ext cx="169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Intensit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5"/>
          <p:cNvSpPr/>
          <p:nvPr/>
        </p:nvSpPr>
        <p:spPr>
          <a:xfrm>
            <a:off x="4191120" y="446580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6"/>
          <p:cNvSpPr/>
          <p:nvPr/>
        </p:nvSpPr>
        <p:spPr>
          <a:xfrm>
            <a:off x="925560" y="457200"/>
            <a:ext cx="7075440" cy="457200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7"/>
          <p:cNvSpPr/>
          <p:nvPr/>
        </p:nvSpPr>
        <p:spPr>
          <a:xfrm>
            <a:off x="1600200" y="5181480"/>
            <a:ext cx="6051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OEU80493.1 hypothetical protein BA872_08985 [Desulfobacterales bacterium C00003060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pectrum from Hydrate Ridge 0-6 cm sediment samp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8"/>
          <p:cNvSpPr/>
          <p:nvPr/>
        </p:nvSpPr>
        <p:spPr>
          <a:xfrm>
            <a:off x="3511080" y="92160"/>
            <a:ext cx="167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ldase prote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3" descr=""/>
          <p:cNvPicPr/>
          <p:nvPr/>
        </p:nvPicPr>
        <p:blipFill>
          <a:blip r:embed="rId1"/>
          <a:srcRect l="2712" t="0" r="0" b="4037"/>
          <a:stretch/>
        </p:blipFill>
        <p:spPr>
          <a:xfrm>
            <a:off x="1465200" y="927000"/>
            <a:ext cx="6078600" cy="3875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7" name="TextBox 4"/>
          <p:cNvSpPr/>
          <p:nvPr/>
        </p:nvSpPr>
        <p:spPr>
          <a:xfrm rot="16200000">
            <a:off x="434160" y="226116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Intensit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5"/>
          <p:cNvSpPr/>
          <p:nvPr/>
        </p:nvSpPr>
        <p:spPr>
          <a:xfrm>
            <a:off x="3733920" y="487692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ectangle 6"/>
          <p:cNvSpPr/>
          <p:nvPr/>
        </p:nvSpPr>
        <p:spPr>
          <a:xfrm>
            <a:off x="1465200" y="5334120"/>
            <a:ext cx="60022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OEU53800.1 hypothetical protein BA868_10095 [Desulfobacterales bacterium C00003106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pectrum from Santa Monica 0-4 cm sediment samp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7"/>
          <p:cNvSpPr/>
          <p:nvPr/>
        </p:nvSpPr>
        <p:spPr>
          <a:xfrm>
            <a:off x="990720" y="762120"/>
            <a:ext cx="6858000" cy="457200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8"/>
          <p:cNvSpPr/>
          <p:nvPr/>
        </p:nvSpPr>
        <p:spPr>
          <a:xfrm>
            <a:off x="3434760" y="392040"/>
            <a:ext cx="167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ldase protein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3" descr=""/>
          <p:cNvPicPr/>
          <p:nvPr/>
        </p:nvPicPr>
        <p:blipFill>
          <a:blip r:embed="rId1"/>
          <a:srcRect l="3126" t="0" r="0" b="4265"/>
          <a:stretch/>
        </p:blipFill>
        <p:spPr>
          <a:xfrm>
            <a:off x="1633680" y="990720"/>
            <a:ext cx="5752800" cy="3989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3" name="TextBox 4"/>
          <p:cNvSpPr/>
          <p:nvPr/>
        </p:nvSpPr>
        <p:spPr>
          <a:xfrm rot="16200000">
            <a:off x="470520" y="248832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Intensit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5"/>
          <p:cNvSpPr/>
          <p:nvPr/>
        </p:nvSpPr>
        <p:spPr>
          <a:xfrm>
            <a:off x="4038480" y="5024520"/>
            <a:ext cx="169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ctangle 6"/>
          <p:cNvSpPr/>
          <p:nvPr/>
        </p:nvSpPr>
        <p:spPr>
          <a:xfrm>
            <a:off x="914400" y="762120"/>
            <a:ext cx="6705720" cy="463212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7"/>
          <p:cNvSpPr/>
          <p:nvPr/>
        </p:nvSpPr>
        <p:spPr>
          <a:xfrm>
            <a:off x="1160640" y="5562720"/>
            <a:ext cx="6459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OEU67620.1 hypothetical protein BBJ57_09125 [Desulfobacterales bacterium PC51MH44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pectrum from Hydrate Ridge 0-6 cm sediment samp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8"/>
          <p:cNvSpPr/>
          <p:nvPr/>
        </p:nvSpPr>
        <p:spPr>
          <a:xfrm>
            <a:off x="3311280" y="392040"/>
            <a:ext cx="21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6 heme cytochrom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3" descr=""/>
          <p:cNvPicPr/>
          <p:nvPr/>
        </p:nvPicPr>
        <p:blipFill>
          <a:blip r:embed="rId1"/>
          <a:srcRect l="3125" t="0" r="0" b="4331"/>
          <a:stretch/>
        </p:blipFill>
        <p:spPr>
          <a:xfrm>
            <a:off x="1633680" y="1143000"/>
            <a:ext cx="5757840" cy="3925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9" name="TextBox 4"/>
          <p:cNvSpPr/>
          <p:nvPr/>
        </p:nvSpPr>
        <p:spPr>
          <a:xfrm rot="16200000">
            <a:off x="470520" y="2521440"/>
            <a:ext cx="169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Intensit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5"/>
          <p:cNvSpPr/>
          <p:nvPr/>
        </p:nvSpPr>
        <p:spPr>
          <a:xfrm>
            <a:off x="3809880" y="5105520"/>
            <a:ext cx="169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6"/>
          <p:cNvSpPr/>
          <p:nvPr/>
        </p:nvSpPr>
        <p:spPr>
          <a:xfrm>
            <a:off x="1131840" y="914400"/>
            <a:ext cx="6488280" cy="464832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ectangle 7"/>
          <p:cNvSpPr/>
          <p:nvPr/>
        </p:nvSpPr>
        <p:spPr>
          <a:xfrm>
            <a:off x="1463760" y="5638680"/>
            <a:ext cx="5986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OEU53798.1 hypothetical protein BA868_10085 [Desulfobacterales bacterium C00003106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pectrum from Santa Monica 0-4 cm sediment samp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tangle 8"/>
          <p:cNvSpPr/>
          <p:nvPr/>
        </p:nvSpPr>
        <p:spPr>
          <a:xfrm>
            <a:off x="3378960" y="542880"/>
            <a:ext cx="21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6 heme cytochrom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Picture 3" descr=""/>
          <p:cNvPicPr/>
          <p:nvPr/>
        </p:nvPicPr>
        <p:blipFill>
          <a:blip r:embed="rId1"/>
          <a:srcRect l="3250" t="0" r="0" b="4103"/>
          <a:stretch/>
        </p:blipFill>
        <p:spPr>
          <a:xfrm>
            <a:off x="1793880" y="1227240"/>
            <a:ext cx="5749920" cy="4224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5" name="TextBox 4"/>
          <p:cNvSpPr/>
          <p:nvPr/>
        </p:nvSpPr>
        <p:spPr>
          <a:xfrm rot="16200000">
            <a:off x="654840" y="279468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Intensity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5"/>
          <p:cNvSpPr/>
          <p:nvPr/>
        </p:nvSpPr>
        <p:spPr>
          <a:xfrm>
            <a:off x="3962520" y="5562720"/>
            <a:ext cx="169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tangle 6"/>
          <p:cNvSpPr/>
          <p:nvPr/>
        </p:nvSpPr>
        <p:spPr>
          <a:xfrm>
            <a:off x="1219320" y="990720"/>
            <a:ext cx="6629400" cy="494172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7"/>
          <p:cNvSpPr/>
          <p:nvPr/>
        </p:nvSpPr>
        <p:spPr>
          <a:xfrm>
            <a:off x="1500120" y="6095880"/>
            <a:ext cx="6272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OEU69591.1 hypothetical protein BA864_05830 [Desulfuromonadales bacterium C0000309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pectrum from Santa Monica 0-4 cm sediment sample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Rectangle 8"/>
          <p:cNvSpPr/>
          <p:nvPr/>
        </p:nvSpPr>
        <p:spPr>
          <a:xfrm>
            <a:off x="3562560" y="533520"/>
            <a:ext cx="2018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HL repeat protein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27T18:06:52Z</dcterms:created>
  <dc:creator>Iyer, Ramsunder M.</dc:creator>
  <dc:description/>
  <dc:language>en-US</dc:language>
  <cp:lastModifiedBy>Microsoft Office User</cp:lastModifiedBy>
  <dcterms:modified xsi:type="dcterms:W3CDTF">2017-03-31T18:48:48Z</dcterms:modified>
  <cp:revision>14</cp:revision>
  <dc:subject/>
  <dc:title>PowerPoint Presentation</dc:title>
</cp:coreProperties>
</file>